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Author" initials="A" userId="Author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5" name="Author" initials="A" lastIdx="0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973" autoAdjust="0"/>
    <p:restoredTop sz="94660"/>
  </p:normalViewPr>
  <p:slideViewPr>
    <p:cSldViewPr snapToGrid="0">
      <p:cViewPr varScale="1">
        <p:scale>
          <a:sx n="66" d="100"/>
          <a:sy n="66" d="100"/>
        </p:scale>
        <p:origin x="71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459D7F-FE00-4DD4-9E50-66E382C778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5082126-D5CD-4827-8148-0BE57BC9B1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93FCCA-2D2C-4261-B4E4-3112961F3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CAA3D9-C172-4195-9E2B-3AB34579C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0A30CB-97B6-4FA7-9BF8-53FE28F2E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90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48F7C9-6DB4-428E-871D-C6F0E07902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C24520B-2225-4A52-8477-EE35EBC6C4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E43F4E-C7CE-48DF-AA62-19A99D64D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8E75CE-4F76-4B4C-8890-5ECC2174D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019FD7-322C-4C87-A9DE-B59CEB164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728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52C0F49-1ABB-4F68-9A10-BDA2036133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9DEF0A6-2BE2-4F1E-AAFA-F85A066481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C349C5-B5E9-4802-866C-B1A5208BC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03ABE2-02A6-4DC5-A290-291B4D140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D4DF06-EBB7-4D88-8FC5-B7F0A01D4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162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924202-1457-436E-A252-8DF8C85B4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9086F52-726D-49DF-A146-C3B7A7E31E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7E58CB7-B968-4E40-A9F4-D5123372D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49FD20-C637-4E50-8930-17ED64CEF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FD8A84-90C0-45F3-AF35-A2E5D5513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848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82EB10-070F-45FB-8C0C-7C9533DC32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DFCF229-552C-4815-B8FF-47EE424B6A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E91A1B-240E-425A-8383-40DBE879F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A0F8C9-CDF2-4E2D-BAF5-A01F3CF13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1B2991-A3E7-47BD-9CFF-6BDCC10EF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776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2CF478-B593-4EBA-AF19-5F54FD0C7A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D3D2E1B-CD49-4AD0-B3C2-2D88AAD55A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C635080-CF43-4352-AFA3-D230FAE078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A992611-E48E-4BD1-AF68-3343270A5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042E135-9F0A-4BE3-B4F6-21D5D340F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134A430-C15D-4EC8-B080-8D798DAB8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339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08A4A3-AD74-433A-A540-CEB6C9F87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9D617BD-4494-4523-8E6D-F020C6AD8C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FB91CB9-7D37-4B37-BA9A-967C131DA3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D812CB-4E21-4828-8396-A53B9F19AD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35E2205-FCE2-4F36-ADFA-02E374610E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7088468-1D82-408D-A205-1C7FA359E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E85D77A-CB01-4B72-AA43-C56A5F3FC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68CEDFE-2907-4317-B60A-77C9F6CA9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564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A4366C-AC31-410E-ABB0-53F30A1507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02F70E6-55B6-442A-A21B-E013B4720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8D62BFA-47A1-4923-91B1-7081D92DA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497154D-28FA-4F8A-9AC7-A66622FB4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58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37283FA-7602-43C6-9287-501378558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265C5D3-0C43-4D33-8D51-C3AA6A630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C038EAE-8257-42C3-B932-55B96ED99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959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2E446F-A378-44F1-AA87-9A905A4259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410D32-F166-4DAD-AFC6-95D06C1E34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FB475E5-6EB3-4F25-BBB4-AB83FE6522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30C183-2582-4B91-ADFA-ECE201BAE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0F807B-4CFA-4C46-8CDA-EB302820A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026F30F-865D-4EF5-B9B0-BBBF53BE0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8819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B1F2F9-6ED9-4485-AD04-798C0B2BD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77C84A7-2BC8-4870-A396-775F495B07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CE71860-2246-4A50-98A7-DB7EAF2767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621105-5D93-4DB2-9783-D4E7F0152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FD0F045-EF8C-487A-9FEC-97C2B7D53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634FC3-8933-4A54-8453-E2234272E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55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241755F-B4E3-4E30-91B0-34B10210D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4BF89AA-B1E9-45B8-8841-3D02F93DDA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1782DD-15B6-44EF-83F2-6A39F3CE23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0B0E5-46FE-4510-B2D8-BB2ED2C87FD2}" type="datetimeFigureOut">
              <a:rPr kumimoji="1" lang="ja-JP" altLang="en-US" smtClean="0"/>
              <a:t>2022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836932-3638-4049-816F-B9C06B701B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2237F5-CECC-4F52-B443-6154C65453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24147-1D84-4ECA-97BC-979BE7E527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608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">
            <a:extLst>
              <a:ext uri="{FF2B5EF4-FFF2-40B4-BE49-F238E27FC236}">
                <a16:creationId xmlns:a16="http://schemas.microsoft.com/office/drawing/2014/main" id="{F09702E6-DE9A-487C-AA3C-9E7493EF81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2575" y="684097"/>
            <a:ext cx="2228850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,799  records identified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rough database searching</a:t>
            </a: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AutoShape 3">
            <a:extLst>
              <a:ext uri="{FF2B5EF4-FFF2-40B4-BE49-F238E27FC236}">
                <a16:creationId xmlns:a16="http://schemas.microsoft.com/office/drawing/2014/main" id="{E85CB026-4A28-4FE9-B069-3FF5362E43E7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2998408" y="25947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creening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AutoShape 4">
            <a:extLst>
              <a:ext uri="{FF2B5EF4-FFF2-40B4-BE49-F238E27FC236}">
                <a16:creationId xmlns:a16="http://schemas.microsoft.com/office/drawing/2014/main" id="{ADB8B652-856E-470D-ADFD-B3CFE5400D40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2998408" y="57951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cluded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AutoShape 5">
            <a:extLst>
              <a:ext uri="{FF2B5EF4-FFF2-40B4-BE49-F238E27FC236}">
                <a16:creationId xmlns:a16="http://schemas.microsoft.com/office/drawing/2014/main" id="{375C1921-DD9D-47CD-B360-3A470956EA02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2998408" y="41949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ligibility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2" name="AutoShape 6">
            <a:extLst>
              <a:ext uri="{FF2B5EF4-FFF2-40B4-BE49-F238E27FC236}">
                <a16:creationId xmlns:a16="http://schemas.microsoft.com/office/drawing/2014/main" id="{32FD68AE-2D4B-4838-AA93-024D5636C8F6}"/>
              </a:ext>
            </a:extLst>
          </p:cNvPr>
          <p:cNvCxnSpPr>
            <a:cxnSpLocks noChangeShapeType="1"/>
            <a:stCxn id="28" idx="2"/>
            <a:endCxn id="36" idx="0"/>
          </p:cNvCxnSpPr>
          <p:nvPr/>
        </p:nvCxnSpPr>
        <p:spPr bwMode="auto">
          <a:xfrm flipH="1">
            <a:off x="5795275" y="1255597"/>
            <a:ext cx="1725" cy="37418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34" name="AutoShape 8">
            <a:extLst>
              <a:ext uri="{FF2B5EF4-FFF2-40B4-BE49-F238E27FC236}">
                <a16:creationId xmlns:a16="http://schemas.microsoft.com/office/drawing/2014/main" id="{4AE07699-90FC-44CC-AE0C-A4A313BD6F8C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2998408" y="9945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dentification</a:t>
            </a:r>
            <a:endParaRPr kumimoji="0" lang="en-CA" altLang="en-US" sz="12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" name="Rectangle 10">
            <a:extLst>
              <a:ext uri="{FF2B5EF4-FFF2-40B4-BE49-F238E27FC236}">
                <a16:creationId xmlns:a16="http://schemas.microsoft.com/office/drawing/2014/main" id="{A33F3072-24BD-4EFA-813A-DCFB479AEA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9387" y="1629784"/>
            <a:ext cx="2771775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,245 </a:t>
            </a:r>
            <a:r>
              <a:rPr lang="en-CA" altLang="en-US" sz="11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</a:t>
            </a: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cords after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uplicates removed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Rectangle 11">
            <a:extLst>
              <a:ext uri="{FF2B5EF4-FFF2-40B4-BE49-F238E27FC236}">
                <a16:creationId xmlns:a16="http://schemas.microsoft.com/office/drawing/2014/main" id="{0167256C-22C3-4E10-9BC4-FB7D1B3AE8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1975" y="2669117"/>
            <a:ext cx="1670050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504 records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creened</a:t>
            </a: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Rectangle 12">
            <a:extLst>
              <a:ext uri="{FF2B5EF4-FFF2-40B4-BE49-F238E27FC236}">
                <a16:creationId xmlns:a16="http://schemas.microsoft.com/office/drawing/2014/main" id="{53A7E592-5AE9-4CFA-8B58-330E10EBCD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1173" y="2538149"/>
            <a:ext cx="1989003" cy="83343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,741 r</a:t>
            </a: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cords excluded with reasons: 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not in English, basic science, or animal studies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Rectangle 13">
            <a:extLst>
              <a:ext uri="{FF2B5EF4-FFF2-40B4-BE49-F238E27FC236}">
                <a16:creationId xmlns:a16="http://schemas.microsoft.com/office/drawing/2014/main" id="{F6D7A936-C445-4282-A02D-910608B8DC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8024" y="3890729"/>
            <a:ext cx="1714500" cy="57724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60 f</a:t>
            </a: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ull-text articles assessed for eligibility</a:t>
            </a: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Rectangle 14">
            <a:extLst>
              <a:ext uri="{FF2B5EF4-FFF2-40B4-BE49-F238E27FC236}">
                <a16:creationId xmlns:a16="http://schemas.microsoft.com/office/drawing/2014/main" id="{A93DE24F-C005-4E30-B13B-E287BA39EA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1172" y="3708451"/>
            <a:ext cx="1989003" cy="94951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R="0" lvl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ull-text articles excluded: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id not meet inclusion criteria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en-US" sz="11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id not report any outcome of interest</a:t>
            </a:r>
            <a:endParaRPr lang="en-CA" altLang="en-US" dirty="0"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41" name="Rectangle 15">
            <a:extLst>
              <a:ext uri="{FF2B5EF4-FFF2-40B4-BE49-F238E27FC236}">
                <a16:creationId xmlns:a16="http://schemas.microsoft.com/office/drawing/2014/main" id="{A73657A8-8256-4AC1-B5FE-1F72090178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7242" y="5854241"/>
            <a:ext cx="171450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0 s</a:t>
            </a:r>
            <a:r>
              <a:rPr kumimoji="0" lang="en-CA" altLang="en-US" sz="1100" b="0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udies included in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eta-analyses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endParaRPr kumimoji="0" lang="en-CA" altLang="en-US" sz="1800" b="0" i="0" u="none" strike="noStrike" cap="none" normalizeH="0" baseline="0" dirty="0">
              <a:ln>
                <a:noFill/>
              </a:ln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Rectangle 16">
            <a:extLst>
              <a:ext uri="{FF2B5EF4-FFF2-40B4-BE49-F238E27FC236}">
                <a16:creationId xmlns:a16="http://schemas.microsoft.com/office/drawing/2014/main" id="{0A9F6373-680E-4190-A4A8-1863F08D5E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9750" y="4818208"/>
            <a:ext cx="171450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53 studies included in qualitative analysis</a:t>
            </a:r>
            <a:endParaRPr kumimoji="0" lang="en-CA" altLang="en-US" sz="1800" b="0" i="0" u="none" strike="noStrike" cap="none" normalizeH="0" baseline="0" dirty="0">
              <a:ln>
                <a:noFill/>
              </a:ln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3" name="AutoShape 17">
            <a:extLst>
              <a:ext uri="{FF2B5EF4-FFF2-40B4-BE49-F238E27FC236}">
                <a16:creationId xmlns:a16="http://schemas.microsoft.com/office/drawing/2014/main" id="{7BAB00F5-0CEB-43DD-9E65-B73CD6782CD5}"/>
              </a:ext>
            </a:extLst>
          </p:cNvPr>
          <p:cNvCxnSpPr>
            <a:cxnSpLocks noChangeShapeType="1"/>
            <a:stCxn id="36" idx="2"/>
            <a:endCxn id="37" idx="0"/>
          </p:cNvCxnSpPr>
          <p:nvPr/>
        </p:nvCxnSpPr>
        <p:spPr bwMode="auto">
          <a:xfrm>
            <a:off x="5795275" y="2201284"/>
            <a:ext cx="1725" cy="467833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46" name="AutoShape 20">
            <a:extLst>
              <a:ext uri="{FF2B5EF4-FFF2-40B4-BE49-F238E27FC236}">
                <a16:creationId xmlns:a16="http://schemas.microsoft.com/office/drawing/2014/main" id="{5D31E868-670E-4676-801F-7724C61D4A88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774492" y="5514397"/>
            <a:ext cx="0" cy="3429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47" name="AutoShape 21">
            <a:extLst>
              <a:ext uri="{FF2B5EF4-FFF2-40B4-BE49-F238E27FC236}">
                <a16:creationId xmlns:a16="http://schemas.microsoft.com/office/drawing/2014/main" id="{D4A7846C-0A7C-4CAF-95F2-0F1B196E4736}"/>
              </a:ext>
            </a:extLst>
          </p:cNvPr>
          <p:cNvCxnSpPr>
            <a:cxnSpLocks noChangeShapeType="1"/>
            <a:stCxn id="37" idx="3"/>
            <a:endCxn id="38" idx="1"/>
          </p:cNvCxnSpPr>
          <p:nvPr/>
        </p:nvCxnSpPr>
        <p:spPr bwMode="auto">
          <a:xfrm>
            <a:off x="6632025" y="2954867"/>
            <a:ext cx="649148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48" name="AutoShape 22">
            <a:extLst>
              <a:ext uri="{FF2B5EF4-FFF2-40B4-BE49-F238E27FC236}">
                <a16:creationId xmlns:a16="http://schemas.microsoft.com/office/drawing/2014/main" id="{D0DB145C-AFF8-498A-853E-92A2F1295EF1}"/>
              </a:ext>
            </a:extLst>
          </p:cNvPr>
          <p:cNvCxnSpPr>
            <a:cxnSpLocks noChangeShapeType="1"/>
            <a:stCxn id="39" idx="3"/>
            <a:endCxn id="40" idx="1"/>
          </p:cNvCxnSpPr>
          <p:nvPr/>
        </p:nvCxnSpPr>
        <p:spPr bwMode="auto">
          <a:xfrm>
            <a:off x="6652524" y="4179352"/>
            <a:ext cx="628648" cy="385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50" name="AutoShape 17">
            <a:extLst>
              <a:ext uri="{FF2B5EF4-FFF2-40B4-BE49-F238E27FC236}">
                <a16:creationId xmlns:a16="http://schemas.microsoft.com/office/drawing/2014/main" id="{23D0B427-F2EB-4606-B9AC-54DCE1AB8D69}"/>
              </a:ext>
            </a:extLst>
          </p:cNvPr>
          <p:cNvCxnSpPr>
            <a:cxnSpLocks noChangeShapeType="1"/>
            <a:stCxn id="37" idx="2"/>
            <a:endCxn id="39" idx="0"/>
          </p:cNvCxnSpPr>
          <p:nvPr/>
        </p:nvCxnSpPr>
        <p:spPr bwMode="auto">
          <a:xfrm flipH="1">
            <a:off x="5795274" y="3240617"/>
            <a:ext cx="1726" cy="650112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51" name="AutoShape 17">
            <a:extLst>
              <a:ext uri="{FF2B5EF4-FFF2-40B4-BE49-F238E27FC236}">
                <a16:creationId xmlns:a16="http://schemas.microsoft.com/office/drawing/2014/main" id="{8975E82B-8FA6-42BC-8B4D-24927FB32A05}"/>
              </a:ext>
            </a:extLst>
          </p:cNvPr>
          <p:cNvCxnSpPr>
            <a:cxnSpLocks noChangeShapeType="1"/>
            <a:stCxn id="39" idx="2"/>
            <a:endCxn id="42" idx="0"/>
          </p:cNvCxnSpPr>
          <p:nvPr/>
        </p:nvCxnSpPr>
        <p:spPr bwMode="auto">
          <a:xfrm>
            <a:off x="5795274" y="4467975"/>
            <a:ext cx="1726" cy="350233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56" name="Rectangle 14">
            <a:extLst>
              <a:ext uri="{FF2B5EF4-FFF2-40B4-BE49-F238E27FC236}">
                <a16:creationId xmlns:a16="http://schemas.microsoft.com/office/drawing/2014/main" id="{3FEEF942-C4BF-4F33-8E24-9977590C96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1174" y="4744390"/>
            <a:ext cx="1989003" cy="83343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R="0" lvl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ull-text articles excluded: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-hoc analysis that did not report data on the full patient population</a:t>
            </a:r>
          </a:p>
        </p:txBody>
      </p:sp>
      <p:cxnSp>
        <p:nvCxnSpPr>
          <p:cNvPr id="57" name="AutoShape 22">
            <a:extLst>
              <a:ext uri="{FF2B5EF4-FFF2-40B4-BE49-F238E27FC236}">
                <a16:creationId xmlns:a16="http://schemas.microsoft.com/office/drawing/2014/main" id="{FD54E66F-13BD-43A3-B68D-073AC23C3381}"/>
              </a:ext>
            </a:extLst>
          </p:cNvPr>
          <p:cNvCxnSpPr>
            <a:cxnSpLocks noChangeShapeType="1"/>
            <a:stCxn id="42" idx="3"/>
            <a:endCxn id="56" idx="1"/>
          </p:cNvCxnSpPr>
          <p:nvPr/>
        </p:nvCxnSpPr>
        <p:spPr bwMode="auto">
          <a:xfrm>
            <a:off x="6654250" y="5161108"/>
            <a:ext cx="626924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A2582046-580B-4474-9B88-0EC562B13C90}"/>
              </a:ext>
            </a:extLst>
          </p:cNvPr>
          <p:cNvSpPr txBox="1"/>
          <p:nvPr/>
        </p:nvSpPr>
        <p:spPr>
          <a:xfrm>
            <a:off x="415636" y="270164"/>
            <a:ext cx="1911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 A.1</a:t>
            </a:r>
          </a:p>
        </p:txBody>
      </p:sp>
    </p:spTree>
    <p:extLst>
      <p:ext uri="{BB962C8B-B14F-4D97-AF65-F5344CB8AC3E}">
        <p14:creationId xmlns:p14="http://schemas.microsoft.com/office/powerpoint/2010/main" val="1462522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5-19T05:31:54Z</dcterms:created>
  <dcterms:modified xsi:type="dcterms:W3CDTF">2022-05-19T08:24:14Z</dcterms:modified>
</cp:coreProperties>
</file>